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28ADCE8-CD41-EC47-A77D-F31D862716BE}" v="7" dt="2024-03-05T12:07:57.1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74"/>
  </p:normalViewPr>
  <p:slideViewPr>
    <p:cSldViewPr snapToGrid="0">
      <p:cViewPr varScale="1">
        <p:scale>
          <a:sx n="124" d="100"/>
          <a:sy n="124" d="100"/>
        </p:scale>
        <p:origin x="4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雄介 國本" userId="37588d4f08e98cf0" providerId="LiveId" clId="{0EA835CC-24E5-4143-BC6F-0F3B5BC2BDBC}"/>
    <pc:docChg chg="undo redo custSel addSld modSld sldOrd">
      <pc:chgData name="雄介 國本" userId="37588d4f08e98cf0" providerId="LiveId" clId="{0EA835CC-24E5-4143-BC6F-0F3B5BC2BDBC}" dt="2023-12-30T01:49:25.051" v="2213" actId="20577"/>
      <pc:docMkLst>
        <pc:docMk/>
      </pc:docMkLst>
      <pc:sldChg chg="modSp mod">
        <pc:chgData name="雄介 國本" userId="37588d4f08e98cf0" providerId="LiveId" clId="{0EA835CC-24E5-4143-BC6F-0F3B5BC2BDBC}" dt="2023-12-30T01:49:25.051" v="2213" actId="20577"/>
        <pc:sldMkLst>
          <pc:docMk/>
          <pc:sldMk cId="3995223067" sldId="256"/>
        </pc:sldMkLst>
        <pc:spChg chg="mod">
          <ac:chgData name="雄介 國本" userId="37588d4f08e98cf0" providerId="LiveId" clId="{0EA835CC-24E5-4143-BC6F-0F3B5BC2BDBC}" dt="2023-12-09T07:22:57.989" v="829" actId="1035"/>
          <ac:spMkLst>
            <pc:docMk/>
            <pc:sldMk cId="3995223067" sldId="256"/>
            <ac:spMk id="2" creationId="{00000000-0000-0000-0000-000000000000}"/>
          </ac:spMkLst>
        </pc:spChg>
        <pc:spChg chg="mod">
          <ac:chgData name="雄介 國本" userId="37588d4f08e98cf0" providerId="LiveId" clId="{0EA835CC-24E5-4143-BC6F-0F3B5BC2BDBC}" dt="2023-12-30T01:49:25.051" v="2213" actId="20577"/>
          <ac:spMkLst>
            <pc:docMk/>
            <pc:sldMk cId="3995223067" sldId="256"/>
            <ac:spMk id="7" creationId="{00000000-0000-0000-0000-000000000000}"/>
          </ac:spMkLst>
        </pc:spChg>
        <pc:spChg chg="mod">
          <ac:chgData name="雄介 國本" userId="37588d4f08e98cf0" providerId="LiveId" clId="{0EA835CC-24E5-4143-BC6F-0F3B5BC2BDBC}" dt="2023-12-09T07:22:57.989" v="829" actId="1035"/>
          <ac:spMkLst>
            <pc:docMk/>
            <pc:sldMk cId="3995223067" sldId="256"/>
            <ac:spMk id="16" creationId="{00000000-0000-0000-0000-000000000000}"/>
          </ac:spMkLst>
        </pc:spChg>
        <pc:spChg chg="mod">
          <ac:chgData name="雄介 國本" userId="37588d4f08e98cf0" providerId="LiveId" clId="{0EA835CC-24E5-4143-BC6F-0F3B5BC2BDBC}" dt="2023-12-09T07:22:57.989" v="829" actId="1035"/>
          <ac:spMkLst>
            <pc:docMk/>
            <pc:sldMk cId="3995223067" sldId="256"/>
            <ac:spMk id="18" creationId="{00000000-0000-0000-0000-000000000000}"/>
          </ac:spMkLst>
        </pc:spChg>
        <pc:spChg chg="mod">
          <ac:chgData name="雄介 國本" userId="37588d4f08e98cf0" providerId="LiveId" clId="{0EA835CC-24E5-4143-BC6F-0F3B5BC2BDBC}" dt="2023-12-09T07:22:57.989" v="829" actId="1035"/>
          <ac:spMkLst>
            <pc:docMk/>
            <pc:sldMk cId="3995223067" sldId="256"/>
            <ac:spMk id="19" creationId="{00000000-0000-0000-0000-000000000000}"/>
          </ac:spMkLst>
        </pc:spChg>
        <pc:spChg chg="mod">
          <ac:chgData name="雄介 國本" userId="37588d4f08e98cf0" providerId="LiveId" clId="{0EA835CC-24E5-4143-BC6F-0F3B5BC2BDBC}" dt="2023-12-09T07:22:57.989" v="829" actId="1035"/>
          <ac:spMkLst>
            <pc:docMk/>
            <pc:sldMk cId="3995223067" sldId="256"/>
            <ac:spMk id="24" creationId="{0E37F554-9227-13D4-6FD4-332C7BFF1109}"/>
          </ac:spMkLst>
        </pc:spChg>
      </pc:sldChg>
      <pc:sldChg chg="addSp delSp modSp new mod">
        <pc:chgData name="雄介 國本" userId="37588d4f08e98cf0" providerId="LiveId" clId="{0EA835CC-24E5-4143-BC6F-0F3B5BC2BDBC}" dt="2023-12-30T01:49:11.329" v="2205" actId="20577"/>
        <pc:sldMkLst>
          <pc:docMk/>
          <pc:sldMk cId="1710634627" sldId="257"/>
        </pc:sldMkLst>
        <pc:spChg chg="del">
          <ac:chgData name="雄介 國本" userId="37588d4f08e98cf0" providerId="LiveId" clId="{0EA835CC-24E5-4143-BC6F-0F3B5BC2BDBC}" dt="2023-12-09T01:41:30.538" v="1" actId="478"/>
          <ac:spMkLst>
            <pc:docMk/>
            <pc:sldMk cId="1710634627" sldId="257"/>
            <ac:spMk id="2" creationId="{C145E583-5DFD-C71B-C1AD-8D3399D8E66C}"/>
          </ac:spMkLst>
        </pc:spChg>
        <pc:spChg chg="del">
          <ac:chgData name="雄介 國本" userId="37588d4f08e98cf0" providerId="LiveId" clId="{0EA835CC-24E5-4143-BC6F-0F3B5BC2BDBC}" dt="2023-12-09T01:41:31.638" v="2" actId="478"/>
          <ac:spMkLst>
            <pc:docMk/>
            <pc:sldMk cId="1710634627" sldId="257"/>
            <ac:spMk id="3" creationId="{B660DB46-C952-0A69-B2B6-BD9D53A2D778}"/>
          </ac:spMkLst>
        </pc:spChg>
        <pc:spChg chg="add mod">
          <ac:chgData name="雄介 國本" userId="37588d4f08e98cf0" providerId="LiveId" clId="{0EA835CC-24E5-4143-BC6F-0F3B5BC2BDBC}" dt="2023-12-30T01:49:11.329" v="2205" actId="20577"/>
          <ac:spMkLst>
            <pc:docMk/>
            <pc:sldMk cId="1710634627" sldId="257"/>
            <ac:spMk id="6" creationId="{98193836-8A23-9253-A7EB-B3C43937C500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8" creationId="{08545DC5-252F-D2DC-F606-8764D8BEF1F1}"/>
          </ac:spMkLst>
        </pc:spChg>
        <pc:spChg chg="add mod">
          <ac:chgData name="雄介 國本" userId="37588d4f08e98cf0" providerId="LiveId" clId="{0EA835CC-24E5-4143-BC6F-0F3B5BC2BDBC}" dt="2023-12-13T01:59:41.236" v="1776" actId="20577"/>
          <ac:spMkLst>
            <pc:docMk/>
            <pc:sldMk cId="1710634627" sldId="257"/>
            <ac:spMk id="9" creationId="{B004AE4B-723A-2D3A-6165-A6B267B2093E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10" creationId="{124591ED-8649-D8DE-EEE3-5D1B0FC78744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11" creationId="{1DC5A1F2-09C1-4944-A9F5-FC4B6AA0DA19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12" creationId="{DAD8731B-F148-0AEA-3A5B-12BA4C24F21A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13" creationId="{595CC04D-7D79-C206-861C-26470E6B14CF}"/>
          </ac:spMkLst>
        </pc:spChg>
        <pc:spChg chg="add del mod">
          <ac:chgData name="雄介 國本" userId="37588d4f08e98cf0" providerId="LiveId" clId="{0EA835CC-24E5-4143-BC6F-0F3B5BC2BDBC}" dt="2023-12-09T07:07:33.612" v="560"/>
          <ac:spMkLst>
            <pc:docMk/>
            <pc:sldMk cId="1710634627" sldId="257"/>
            <ac:spMk id="14" creationId="{1CBED33C-162E-1BBC-997F-72C797741FAD}"/>
          </ac:spMkLst>
        </pc:spChg>
        <pc:spChg chg="add del mod">
          <ac:chgData name="雄介 國本" userId="37588d4f08e98cf0" providerId="LiveId" clId="{0EA835CC-24E5-4143-BC6F-0F3B5BC2BDBC}" dt="2023-12-09T07:09:10.013" v="566"/>
          <ac:spMkLst>
            <pc:docMk/>
            <pc:sldMk cId="1710634627" sldId="257"/>
            <ac:spMk id="15" creationId="{B06B54B1-C660-811A-982C-54136D80D02B}"/>
          </ac:spMkLst>
        </pc:spChg>
        <pc:spChg chg="add del mod">
          <ac:chgData name="雄介 國本" userId="37588d4f08e98cf0" providerId="LiveId" clId="{0EA835CC-24E5-4143-BC6F-0F3B5BC2BDBC}" dt="2023-12-09T07:10:54.439" v="568"/>
          <ac:spMkLst>
            <pc:docMk/>
            <pc:sldMk cId="1710634627" sldId="257"/>
            <ac:spMk id="16" creationId="{E6442BF3-47A0-2D9E-2CCE-E6D8330EDE99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17" creationId="{DABE02A8-8F55-98FC-93C4-9E1A27C2ADBE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18" creationId="{61790D30-C1A0-CEB0-8570-076757AC410F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19" creationId="{5CB318FD-6C7F-5B91-838B-92072E233BD9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0" creationId="{6D758027-9717-A6F8-F646-61D52F71E009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1" creationId="{71EAD554-5EFC-0947-AF53-C6B338B94E28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2" creationId="{17010B0F-7D3B-F6F9-E399-72D53D8F466B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3" creationId="{48B4E0B9-12D1-C7E1-3EA0-123FA9115E80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4" creationId="{7449D46F-E7D8-27BF-DFB4-C2D1CA0D6231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5" creationId="{0BC93F26-7D43-BA66-5674-B829740402CD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6" creationId="{518650EF-559B-852D-E7E1-8A38BC5CABA8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7" creationId="{4F77E2B9-A404-B719-F08D-A43363E1FA35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8" creationId="{0484A3D6-267C-E7A2-F327-A7C2AD965B4D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29" creationId="{896ABB96-E394-8084-D124-3B0B347ECD01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0" creationId="{904D01F6-81D1-8E30-9D6F-B76CB5CE88F3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1" creationId="{FEA3CD6E-044A-9CC8-84BD-7621CD4F6E5B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2" creationId="{D1EC6D6E-76E0-3106-63BE-B18D4CC03816}"/>
          </ac:spMkLst>
        </pc:spChg>
        <pc:spChg chg="add del mod">
          <ac:chgData name="雄介 國本" userId="37588d4f08e98cf0" providerId="LiveId" clId="{0EA835CC-24E5-4143-BC6F-0F3B5BC2BDBC}" dt="2023-12-09T07:31:26.502" v="1373"/>
          <ac:spMkLst>
            <pc:docMk/>
            <pc:sldMk cId="1710634627" sldId="257"/>
            <ac:spMk id="33" creationId="{19FF7DBA-AE8B-D534-4DB0-F15A4420CE7C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4" creationId="{320DD255-E0EF-06C9-3826-1ACCC7769F4D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5" creationId="{422E7F35-AC46-DC9F-65BF-E20425FB766A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6" creationId="{3F87955C-17AA-C99C-A7C9-B0935F064798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7" creationId="{F8B4A4AC-A6E1-AC32-D171-D9B972CEB155}"/>
          </ac:spMkLst>
        </pc:spChg>
        <pc:spChg chg="add mod">
          <ac:chgData name="雄介 國本" userId="37588d4f08e98cf0" providerId="LiveId" clId="{0EA835CC-24E5-4143-BC6F-0F3B5BC2BDBC}" dt="2023-12-09T08:59:58.337" v="1773" actId="1036"/>
          <ac:spMkLst>
            <pc:docMk/>
            <pc:sldMk cId="1710634627" sldId="257"/>
            <ac:spMk id="38" creationId="{3CB2A57F-5FC6-A184-E84D-3D28CC3C214B}"/>
          </ac:spMkLst>
        </pc:spChg>
        <pc:spChg chg="add mod">
          <ac:chgData name="雄介 國本" userId="37588d4f08e98cf0" providerId="LiveId" clId="{0EA835CC-24E5-4143-BC6F-0F3B5BC2BDBC}" dt="2023-12-09T09:00:02.443" v="1775" actId="1076"/>
          <ac:spMkLst>
            <pc:docMk/>
            <pc:sldMk cId="1710634627" sldId="257"/>
            <ac:spMk id="39" creationId="{0AAD6080-16CC-2D23-62B7-CAFF69F8705C}"/>
          </ac:spMkLst>
        </pc:spChg>
        <pc:graphicFrameChg chg="add mod">
          <ac:chgData name="雄介 國本" userId="37588d4f08e98cf0" providerId="LiveId" clId="{0EA835CC-24E5-4143-BC6F-0F3B5BC2BDBC}" dt="2023-12-09T07:30:21.759" v="1259"/>
          <ac:graphicFrameMkLst>
            <pc:docMk/>
            <pc:sldMk cId="1710634627" sldId="257"/>
            <ac:graphicFrameMk id="4" creationId="{D8362EF2-EEE9-F96B-8E46-7BCF51F11861}"/>
          </ac:graphicFrameMkLst>
        </pc:graphicFrameChg>
      </pc:sldChg>
      <pc:sldChg chg="addSp delSp modSp new mod ord">
        <pc:chgData name="雄介 國本" userId="37588d4f08e98cf0" providerId="LiveId" clId="{0EA835CC-24E5-4143-BC6F-0F3B5BC2BDBC}" dt="2023-12-19T06:40:08.425" v="2162" actId="14100"/>
        <pc:sldMkLst>
          <pc:docMk/>
          <pc:sldMk cId="558466156" sldId="258"/>
        </pc:sldMkLst>
        <pc:spChg chg="del">
          <ac:chgData name="雄介 國本" userId="37588d4f08e98cf0" providerId="LiveId" clId="{0EA835CC-24E5-4143-BC6F-0F3B5BC2BDBC}" dt="2023-12-19T05:36:18.971" v="1814" actId="478"/>
          <ac:spMkLst>
            <pc:docMk/>
            <pc:sldMk cId="558466156" sldId="258"/>
            <ac:spMk id="2" creationId="{7FD72134-4F3A-34DB-41A4-6B8E6B063AAE}"/>
          </ac:spMkLst>
        </pc:spChg>
        <pc:spChg chg="del">
          <ac:chgData name="雄介 國本" userId="37588d4f08e98cf0" providerId="LiveId" clId="{0EA835CC-24E5-4143-BC6F-0F3B5BC2BDBC}" dt="2023-12-19T05:36:21.242" v="1815" actId="478"/>
          <ac:spMkLst>
            <pc:docMk/>
            <pc:sldMk cId="558466156" sldId="258"/>
            <ac:spMk id="3" creationId="{A4C9CB13-75B7-E1D9-2544-05BFD5FD2C35}"/>
          </ac:spMkLst>
        </pc:spChg>
        <pc:spChg chg="add mod">
          <ac:chgData name="雄介 國本" userId="37588d4f08e98cf0" providerId="LiveId" clId="{0EA835CC-24E5-4143-BC6F-0F3B5BC2BDBC}" dt="2023-12-19T06:39:55.553" v="2131" actId="1036"/>
          <ac:spMkLst>
            <pc:docMk/>
            <pc:sldMk cId="558466156" sldId="258"/>
            <ac:spMk id="4" creationId="{DC7325EB-93C6-AB5D-A6D5-3CFC091DE79C}"/>
          </ac:spMkLst>
        </pc:spChg>
        <pc:spChg chg="add mod">
          <ac:chgData name="雄介 國本" userId="37588d4f08e98cf0" providerId="LiveId" clId="{0EA835CC-24E5-4143-BC6F-0F3B5BC2BDBC}" dt="2023-12-19T06:39:55.553" v="2131" actId="1036"/>
          <ac:spMkLst>
            <pc:docMk/>
            <pc:sldMk cId="558466156" sldId="258"/>
            <ac:spMk id="5" creationId="{65DF0F4D-FD75-5E82-3EBD-91E137AA0AA1}"/>
          </ac:spMkLst>
        </pc:spChg>
        <pc:spChg chg="add mod">
          <ac:chgData name="雄介 國本" userId="37588d4f08e98cf0" providerId="LiveId" clId="{0EA835CC-24E5-4143-BC6F-0F3B5BC2BDBC}" dt="2023-12-19T06:39:55.553" v="2131" actId="1036"/>
          <ac:spMkLst>
            <pc:docMk/>
            <pc:sldMk cId="558466156" sldId="258"/>
            <ac:spMk id="6" creationId="{406A7FA7-3B6A-55B2-6A1C-9121E203434C}"/>
          </ac:spMkLst>
        </pc:spChg>
        <pc:spChg chg="add mod">
          <ac:chgData name="雄介 國本" userId="37588d4f08e98cf0" providerId="LiveId" clId="{0EA835CC-24E5-4143-BC6F-0F3B5BC2BDBC}" dt="2023-12-19T06:39:55.553" v="2131" actId="1036"/>
          <ac:spMkLst>
            <pc:docMk/>
            <pc:sldMk cId="558466156" sldId="258"/>
            <ac:spMk id="10" creationId="{242B65AC-3A50-5B7B-6A1C-66E7F0E0817A}"/>
          </ac:spMkLst>
        </pc:spChg>
        <pc:spChg chg="add del mod">
          <ac:chgData name="雄介 國本" userId="37588d4f08e98cf0" providerId="LiveId" clId="{0EA835CC-24E5-4143-BC6F-0F3B5BC2BDBC}" dt="2023-12-19T06:39:47.546" v="2111" actId="478"/>
          <ac:spMkLst>
            <pc:docMk/>
            <pc:sldMk cId="558466156" sldId="258"/>
            <ac:spMk id="11" creationId="{23192283-E590-C670-A118-29D63007C0E1}"/>
          </ac:spMkLst>
        </pc:spChg>
        <pc:spChg chg="add mod">
          <ac:chgData name="雄介 國本" userId="37588d4f08e98cf0" providerId="LiveId" clId="{0EA835CC-24E5-4143-BC6F-0F3B5BC2BDBC}" dt="2023-12-19T06:40:08.425" v="2162" actId="14100"/>
          <ac:spMkLst>
            <pc:docMk/>
            <pc:sldMk cId="558466156" sldId="258"/>
            <ac:spMk id="12" creationId="{DB5E8374-9612-00AB-B086-3B1B711B2D64}"/>
          </ac:spMkLst>
        </pc:spChg>
        <pc:cxnChg chg="add mod">
          <ac:chgData name="雄介 國本" userId="37588d4f08e98cf0" providerId="LiveId" clId="{0EA835CC-24E5-4143-BC6F-0F3B5BC2BDBC}" dt="2023-12-19T06:39:55.553" v="2131" actId="1036"/>
          <ac:cxnSpMkLst>
            <pc:docMk/>
            <pc:sldMk cId="558466156" sldId="258"/>
            <ac:cxnSpMk id="7" creationId="{5722A906-4AE0-0EFE-2320-D7BA8128C16C}"/>
          </ac:cxnSpMkLst>
        </pc:cxnChg>
        <pc:cxnChg chg="add mod">
          <ac:chgData name="雄介 國本" userId="37588d4f08e98cf0" providerId="LiveId" clId="{0EA835CC-24E5-4143-BC6F-0F3B5BC2BDBC}" dt="2023-12-19T06:39:55.553" v="2131" actId="1036"/>
          <ac:cxnSpMkLst>
            <pc:docMk/>
            <pc:sldMk cId="558466156" sldId="258"/>
            <ac:cxnSpMk id="8" creationId="{E7ECB3ED-7415-E950-32FB-E7320D36774E}"/>
          </ac:cxnSpMkLst>
        </pc:cxnChg>
      </pc:sldChg>
    </pc:docChg>
  </pc:docChgLst>
  <pc:docChgLst>
    <pc:chgData name="雄介 國本" userId="37588d4f08e98cf0" providerId="LiveId" clId="{FF2A9FED-7758-BA49-834A-9397D43FCF5B}"/>
    <pc:docChg chg="undo redo custSel modSld">
      <pc:chgData name="雄介 國本" userId="37588d4f08e98cf0" providerId="LiveId" clId="{FF2A9FED-7758-BA49-834A-9397D43FCF5B}" dt="2024-01-24T00:43:05.373" v="408" actId="20577"/>
      <pc:docMkLst>
        <pc:docMk/>
      </pc:docMkLst>
      <pc:sldChg chg="addSp delSp modSp mod">
        <pc:chgData name="雄介 國本" userId="37588d4f08e98cf0" providerId="LiveId" clId="{FF2A9FED-7758-BA49-834A-9397D43FCF5B}" dt="2024-01-24T00:42:29.734" v="398" actId="20577"/>
        <pc:sldMkLst>
          <pc:docMk/>
          <pc:sldMk cId="3995223067" sldId="256"/>
        </pc:sldMkLst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2" creationId="{00000000-0000-0000-0000-000000000000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3" creationId="{00000000-0000-0000-0000-000000000000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5" creationId="{F85C195C-9099-F836-E846-2453506E9D0A}"/>
          </ac:spMkLst>
        </pc:spChg>
        <pc:spChg chg="add mod">
          <ac:chgData name="雄介 國本" userId="37588d4f08e98cf0" providerId="LiveId" clId="{FF2A9FED-7758-BA49-834A-9397D43FCF5B}" dt="2024-01-24T00:21:18.266" v="99" actId="1035"/>
          <ac:spMkLst>
            <pc:docMk/>
            <pc:sldMk cId="3995223067" sldId="256"/>
            <ac:spMk id="6" creationId="{00EA0DC6-3E3B-1B5E-212E-7C773BEA3180}"/>
          </ac:spMkLst>
        </pc:spChg>
        <pc:spChg chg="mod">
          <ac:chgData name="雄介 國本" userId="37588d4f08e98cf0" providerId="LiveId" clId="{FF2A9FED-7758-BA49-834A-9397D43FCF5B}" dt="2024-01-24T00:42:29.734" v="398" actId="20577"/>
          <ac:spMkLst>
            <pc:docMk/>
            <pc:sldMk cId="3995223067" sldId="256"/>
            <ac:spMk id="7" creationId="{00000000-0000-0000-0000-000000000000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8" creationId="{51387C98-E8B6-BD17-F2EB-B86EF344DAB5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10" creationId="{5585EBF8-E0C6-2655-D584-8CF4C49D36B3}"/>
          </ac:spMkLst>
        </pc:spChg>
        <pc:spChg chg="add mod">
          <ac:chgData name="雄介 國本" userId="37588d4f08e98cf0" providerId="LiveId" clId="{FF2A9FED-7758-BA49-834A-9397D43FCF5B}" dt="2024-01-24T00:21:18.266" v="99" actId="1035"/>
          <ac:spMkLst>
            <pc:docMk/>
            <pc:sldMk cId="3995223067" sldId="256"/>
            <ac:spMk id="11" creationId="{4ECD5240-38CC-C830-98F9-7342629D2522}"/>
          </ac:spMkLst>
        </pc:spChg>
        <pc:spChg chg="add mod">
          <ac:chgData name="雄介 國本" userId="37588d4f08e98cf0" providerId="LiveId" clId="{FF2A9FED-7758-BA49-834A-9397D43FCF5B}" dt="2024-01-24T00:21:18.266" v="99" actId="1035"/>
          <ac:spMkLst>
            <pc:docMk/>
            <pc:sldMk cId="3995223067" sldId="256"/>
            <ac:spMk id="12" creationId="{B6DDE6B7-FD71-8208-F218-41A9D96CF440}"/>
          </ac:spMkLst>
        </pc:spChg>
        <pc:spChg chg="add mod">
          <ac:chgData name="雄介 國本" userId="37588d4f08e98cf0" providerId="LiveId" clId="{FF2A9FED-7758-BA49-834A-9397D43FCF5B}" dt="2024-01-24T00:21:18.266" v="99" actId="1035"/>
          <ac:spMkLst>
            <pc:docMk/>
            <pc:sldMk cId="3995223067" sldId="256"/>
            <ac:spMk id="13" creationId="{9C29CBA1-96FE-1F95-6B6E-50122C3DDC53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16" creationId="{00000000-0000-0000-0000-000000000000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17" creationId="{00000000-0000-0000-0000-000000000000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18" creationId="{00000000-0000-0000-0000-000000000000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19" creationId="{00000000-0000-0000-0000-000000000000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20" creationId="{3754B42C-9907-AA6C-7AA0-5C48B888B8EA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21" creationId="{E24E748A-1E95-4B2C-4DB9-70AE8FF0A3C9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22" creationId="{677D8F34-2E48-6BD3-22E0-C54471387A32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23" creationId="{0AE39B81-3D23-A5FD-1B40-1CF6F6647E44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24" creationId="{0E37F554-9227-13D4-6FD4-332C7BFF1109}"/>
          </ac:spMkLst>
        </pc:spChg>
        <pc:spChg chg="mod">
          <ac:chgData name="雄介 國本" userId="37588d4f08e98cf0" providerId="LiveId" clId="{FF2A9FED-7758-BA49-834A-9397D43FCF5B}" dt="2024-01-24T00:21:03.163" v="75" actId="1037"/>
          <ac:spMkLst>
            <pc:docMk/>
            <pc:sldMk cId="3995223067" sldId="256"/>
            <ac:spMk id="25" creationId="{DACF262F-4A98-6EC5-75FD-586D5F874D5B}"/>
          </ac:spMkLst>
        </pc:spChg>
        <pc:picChg chg="mod">
          <ac:chgData name="雄介 國本" userId="37588d4f08e98cf0" providerId="LiveId" clId="{FF2A9FED-7758-BA49-834A-9397D43FCF5B}" dt="2024-01-24T00:21:03.163" v="75" actId="1037"/>
          <ac:picMkLst>
            <pc:docMk/>
            <pc:sldMk cId="3995223067" sldId="256"/>
            <ac:picMk id="4" creationId="{F6783AAF-2CC5-5701-E38C-2D95ABCFFA9F}"/>
          </ac:picMkLst>
        </pc:picChg>
        <pc:picChg chg="del mod">
          <ac:chgData name="雄介 國本" userId="37588d4f08e98cf0" providerId="LiveId" clId="{FF2A9FED-7758-BA49-834A-9397D43FCF5B}" dt="2024-01-24T00:21:08.204" v="76" actId="478"/>
          <ac:picMkLst>
            <pc:docMk/>
            <pc:sldMk cId="3995223067" sldId="256"/>
            <ac:picMk id="9" creationId="{D4B51062-ACB7-07DC-22DD-6BAAD7911350}"/>
          </ac:picMkLst>
        </pc:picChg>
      </pc:sldChg>
      <pc:sldChg chg="addSp modSp mod">
        <pc:chgData name="雄介 國本" userId="37588d4f08e98cf0" providerId="LiveId" clId="{FF2A9FED-7758-BA49-834A-9397D43FCF5B}" dt="2024-01-24T00:43:05.373" v="408" actId="20577"/>
        <pc:sldMkLst>
          <pc:docMk/>
          <pc:sldMk cId="1710634627" sldId="257"/>
        </pc:sldMkLst>
        <pc:spChg chg="add mod">
          <ac:chgData name="雄介 國本" userId="37588d4f08e98cf0" providerId="LiveId" clId="{FF2A9FED-7758-BA49-834A-9397D43FCF5B}" dt="2024-01-24T00:29:05.206" v="232" actId="1036"/>
          <ac:spMkLst>
            <pc:docMk/>
            <pc:sldMk cId="1710634627" sldId="257"/>
            <ac:spMk id="2" creationId="{428630CC-7631-6A5F-FE27-11B059A9C2AA}"/>
          </ac:spMkLst>
        </pc:spChg>
        <pc:spChg chg="add mod">
          <ac:chgData name="雄介 國本" userId="37588d4f08e98cf0" providerId="LiveId" clId="{FF2A9FED-7758-BA49-834A-9397D43FCF5B}" dt="2024-01-24T00:29:05.206" v="232" actId="1036"/>
          <ac:spMkLst>
            <pc:docMk/>
            <pc:sldMk cId="1710634627" sldId="257"/>
            <ac:spMk id="3" creationId="{4325ED72-EA27-CD66-4370-55EE86959C54}"/>
          </ac:spMkLst>
        </pc:spChg>
        <pc:spChg chg="add mod">
          <ac:chgData name="雄介 國本" userId="37588d4f08e98cf0" providerId="LiveId" clId="{FF2A9FED-7758-BA49-834A-9397D43FCF5B}" dt="2024-01-24T00:29:05.206" v="232" actId="1036"/>
          <ac:spMkLst>
            <pc:docMk/>
            <pc:sldMk cId="1710634627" sldId="257"/>
            <ac:spMk id="5" creationId="{FDB2ED21-1830-059C-F8BE-A4F9EA4FF226}"/>
          </ac:spMkLst>
        </pc:spChg>
        <pc:spChg chg="mod">
          <ac:chgData name="雄介 國本" userId="37588d4f08e98cf0" providerId="LiveId" clId="{FF2A9FED-7758-BA49-834A-9397D43FCF5B}" dt="2024-01-24T00:43:05.373" v="408" actId="20577"/>
          <ac:spMkLst>
            <pc:docMk/>
            <pc:sldMk cId="1710634627" sldId="257"/>
            <ac:spMk id="6" creationId="{98193836-8A23-9253-A7EB-B3C43937C500}"/>
          </ac:spMkLst>
        </pc:spChg>
        <pc:spChg chg="add mod">
          <ac:chgData name="雄介 國本" userId="37588d4f08e98cf0" providerId="LiveId" clId="{FF2A9FED-7758-BA49-834A-9397D43FCF5B}" dt="2024-01-24T00:29:05.206" v="232" actId="1036"/>
          <ac:spMkLst>
            <pc:docMk/>
            <pc:sldMk cId="1710634627" sldId="257"/>
            <ac:spMk id="7" creationId="{48FD892D-E380-4324-0B51-ED64227473EC}"/>
          </ac:spMkLst>
        </pc:spChg>
        <pc:spChg chg="mod">
          <ac:chgData name="雄介 國本" userId="37588d4f08e98cf0" providerId="LiveId" clId="{FF2A9FED-7758-BA49-834A-9397D43FCF5B}" dt="2024-01-24T00:40:55.669" v="390" actId="1076"/>
          <ac:spMkLst>
            <pc:docMk/>
            <pc:sldMk cId="1710634627" sldId="257"/>
            <ac:spMk id="12" creationId="{DAD8731B-F148-0AEA-3A5B-12BA4C24F21A}"/>
          </ac:spMkLst>
        </pc:spChg>
        <pc:spChg chg="mod">
          <ac:chgData name="雄介 國本" userId="37588d4f08e98cf0" providerId="LiveId" clId="{FF2A9FED-7758-BA49-834A-9397D43FCF5B}" dt="2024-01-24T00:29:26.137" v="242" actId="1036"/>
          <ac:spMkLst>
            <pc:docMk/>
            <pc:sldMk cId="1710634627" sldId="257"/>
            <ac:spMk id="13" creationId="{595CC04D-7D79-C206-861C-26470E6B14CF}"/>
          </ac:spMkLst>
        </pc:spChg>
        <pc:spChg chg="mod">
          <ac:chgData name="雄介 國本" userId="37588d4f08e98cf0" providerId="LiveId" clId="{FF2A9FED-7758-BA49-834A-9397D43FCF5B}" dt="2024-01-24T00:33:43.139" v="322" actId="1076"/>
          <ac:spMkLst>
            <pc:docMk/>
            <pc:sldMk cId="1710634627" sldId="257"/>
            <ac:spMk id="17" creationId="{DABE02A8-8F55-98FC-93C4-9E1A27C2ADBE}"/>
          </ac:spMkLst>
        </pc:spChg>
        <pc:spChg chg="mod">
          <ac:chgData name="雄介 國本" userId="37588d4f08e98cf0" providerId="LiveId" clId="{FF2A9FED-7758-BA49-834A-9397D43FCF5B}" dt="2024-01-24T00:33:59.572" v="335" actId="1076"/>
          <ac:spMkLst>
            <pc:docMk/>
            <pc:sldMk cId="1710634627" sldId="257"/>
            <ac:spMk id="18" creationId="{61790D30-C1A0-CEB0-8570-076757AC410F}"/>
          </ac:spMkLst>
        </pc:spChg>
        <pc:spChg chg="mod">
          <ac:chgData name="雄介 國本" userId="37588d4f08e98cf0" providerId="LiveId" clId="{FF2A9FED-7758-BA49-834A-9397D43FCF5B}" dt="2024-01-24T00:29:26.137" v="242" actId="1036"/>
          <ac:spMkLst>
            <pc:docMk/>
            <pc:sldMk cId="1710634627" sldId="257"/>
            <ac:spMk id="19" creationId="{5CB318FD-6C7F-5B91-838B-92072E233BD9}"/>
          </ac:spMkLst>
        </pc:spChg>
        <pc:spChg chg="mod">
          <ac:chgData name="雄介 國本" userId="37588d4f08e98cf0" providerId="LiveId" clId="{FF2A9FED-7758-BA49-834A-9397D43FCF5B}" dt="2024-01-24T00:29:26.137" v="242" actId="1036"/>
          <ac:spMkLst>
            <pc:docMk/>
            <pc:sldMk cId="1710634627" sldId="257"/>
            <ac:spMk id="20" creationId="{6D758027-9717-A6F8-F646-61D52F71E009}"/>
          </ac:spMkLst>
        </pc:spChg>
        <pc:spChg chg="mod">
          <ac:chgData name="雄介 國本" userId="37588d4f08e98cf0" providerId="LiveId" clId="{FF2A9FED-7758-BA49-834A-9397D43FCF5B}" dt="2024-01-24T00:29:26.137" v="242" actId="1036"/>
          <ac:spMkLst>
            <pc:docMk/>
            <pc:sldMk cId="1710634627" sldId="257"/>
            <ac:spMk id="21" creationId="{71EAD554-5EFC-0947-AF53-C6B338B94E28}"/>
          </ac:spMkLst>
        </pc:spChg>
        <pc:spChg chg="mod">
          <ac:chgData name="雄介 國本" userId="37588d4f08e98cf0" providerId="LiveId" clId="{FF2A9FED-7758-BA49-834A-9397D43FCF5B}" dt="2024-01-24T00:29:26.137" v="242" actId="1036"/>
          <ac:spMkLst>
            <pc:docMk/>
            <pc:sldMk cId="1710634627" sldId="257"/>
            <ac:spMk id="22" creationId="{17010B0F-7D3B-F6F9-E399-72D53D8F466B}"/>
          </ac:spMkLst>
        </pc:spChg>
        <pc:spChg chg="mod">
          <ac:chgData name="雄介 國本" userId="37588d4f08e98cf0" providerId="LiveId" clId="{FF2A9FED-7758-BA49-834A-9397D43FCF5B}" dt="2024-01-24T00:33:35.622" v="321" actId="1076"/>
          <ac:spMkLst>
            <pc:docMk/>
            <pc:sldMk cId="1710634627" sldId="257"/>
            <ac:spMk id="23" creationId="{48B4E0B9-12D1-C7E1-3EA0-123FA9115E80}"/>
          </ac:spMkLst>
        </pc:spChg>
        <pc:spChg chg="mod">
          <ac:chgData name="雄介 國本" userId="37588d4f08e98cf0" providerId="LiveId" clId="{FF2A9FED-7758-BA49-834A-9397D43FCF5B}" dt="2024-01-24T00:36:57.756" v="365" actId="1076"/>
          <ac:spMkLst>
            <pc:docMk/>
            <pc:sldMk cId="1710634627" sldId="257"/>
            <ac:spMk id="26" creationId="{518650EF-559B-852D-E7E1-8A38BC5CABA8}"/>
          </ac:spMkLst>
        </pc:spChg>
        <pc:spChg chg="mod">
          <ac:chgData name="雄介 國本" userId="37588d4f08e98cf0" providerId="LiveId" clId="{FF2A9FED-7758-BA49-834A-9397D43FCF5B}" dt="2024-01-24T00:34:07.748" v="336" actId="1076"/>
          <ac:spMkLst>
            <pc:docMk/>
            <pc:sldMk cId="1710634627" sldId="257"/>
            <ac:spMk id="27" creationId="{4F77E2B9-A404-B719-F08D-A43363E1FA35}"/>
          </ac:spMkLst>
        </pc:spChg>
        <pc:spChg chg="mod">
          <ac:chgData name="雄介 國本" userId="37588d4f08e98cf0" providerId="LiveId" clId="{FF2A9FED-7758-BA49-834A-9397D43FCF5B}" dt="2024-01-24T00:40:24.690" v="388" actId="1076"/>
          <ac:spMkLst>
            <pc:docMk/>
            <pc:sldMk cId="1710634627" sldId="257"/>
            <ac:spMk id="28" creationId="{0484A3D6-267C-E7A2-F327-A7C2AD965B4D}"/>
          </ac:spMkLst>
        </pc:spChg>
        <pc:spChg chg="mod">
          <ac:chgData name="雄介 國本" userId="37588d4f08e98cf0" providerId="LiveId" clId="{FF2A9FED-7758-BA49-834A-9397D43FCF5B}" dt="2024-01-24T00:36:40.164" v="364" actId="1038"/>
          <ac:spMkLst>
            <pc:docMk/>
            <pc:sldMk cId="1710634627" sldId="257"/>
            <ac:spMk id="29" creationId="{896ABB96-E394-8084-D124-3B0B347ECD01}"/>
          </ac:spMkLst>
        </pc:spChg>
        <pc:spChg chg="mod">
          <ac:chgData name="雄介 國本" userId="37588d4f08e98cf0" providerId="LiveId" clId="{FF2A9FED-7758-BA49-834A-9397D43FCF5B}" dt="2024-01-24T00:36:10.743" v="358" actId="1037"/>
          <ac:spMkLst>
            <pc:docMk/>
            <pc:sldMk cId="1710634627" sldId="257"/>
            <ac:spMk id="30" creationId="{904D01F6-81D1-8E30-9D6F-B76CB5CE88F3}"/>
          </ac:spMkLst>
        </pc:spChg>
        <pc:spChg chg="mod">
          <ac:chgData name="雄介 國本" userId="37588d4f08e98cf0" providerId="LiveId" clId="{FF2A9FED-7758-BA49-834A-9397D43FCF5B}" dt="2024-01-24T00:35:33.921" v="343" actId="1076"/>
          <ac:spMkLst>
            <pc:docMk/>
            <pc:sldMk cId="1710634627" sldId="257"/>
            <ac:spMk id="31" creationId="{FEA3CD6E-044A-9CC8-84BD-7621CD4F6E5B}"/>
          </ac:spMkLst>
        </pc:spChg>
        <pc:spChg chg="mod">
          <ac:chgData name="雄介 國本" userId="37588d4f08e98cf0" providerId="LiveId" clId="{FF2A9FED-7758-BA49-834A-9397D43FCF5B}" dt="2024-01-24T00:32:22.869" v="281" actId="1076"/>
          <ac:spMkLst>
            <pc:docMk/>
            <pc:sldMk cId="1710634627" sldId="257"/>
            <ac:spMk id="32" creationId="{D1EC6D6E-76E0-3106-63BE-B18D4CC03816}"/>
          </ac:spMkLst>
        </pc:spChg>
        <pc:spChg chg="mod">
          <ac:chgData name="雄介 國本" userId="37588d4f08e98cf0" providerId="LiveId" clId="{FF2A9FED-7758-BA49-834A-9397D43FCF5B}" dt="2024-01-24T00:35:48.376" v="347" actId="1076"/>
          <ac:spMkLst>
            <pc:docMk/>
            <pc:sldMk cId="1710634627" sldId="257"/>
            <ac:spMk id="34" creationId="{320DD255-E0EF-06C9-3826-1ACCC7769F4D}"/>
          </ac:spMkLst>
        </pc:spChg>
        <pc:spChg chg="mod">
          <ac:chgData name="雄介 國本" userId="37588d4f08e98cf0" providerId="LiveId" clId="{FF2A9FED-7758-BA49-834A-9397D43FCF5B}" dt="2024-01-24T00:33:27.279" v="320" actId="1037"/>
          <ac:spMkLst>
            <pc:docMk/>
            <pc:sldMk cId="1710634627" sldId="257"/>
            <ac:spMk id="35" creationId="{422E7F35-AC46-DC9F-65BF-E20425FB766A}"/>
          </ac:spMkLst>
        </pc:spChg>
        <pc:spChg chg="mod">
          <ac:chgData name="雄介 國本" userId="37588d4f08e98cf0" providerId="LiveId" clId="{FF2A9FED-7758-BA49-834A-9397D43FCF5B}" dt="2024-01-24T00:29:26.137" v="242" actId="1036"/>
          <ac:spMkLst>
            <pc:docMk/>
            <pc:sldMk cId="1710634627" sldId="257"/>
            <ac:spMk id="36" creationId="{3F87955C-17AA-C99C-A7C9-B0935F064798}"/>
          </ac:spMkLst>
        </pc:spChg>
        <pc:spChg chg="mod">
          <ac:chgData name="雄介 國本" userId="37588d4f08e98cf0" providerId="LiveId" clId="{FF2A9FED-7758-BA49-834A-9397D43FCF5B}" dt="2024-01-24T00:29:26.137" v="242" actId="1036"/>
          <ac:spMkLst>
            <pc:docMk/>
            <pc:sldMk cId="1710634627" sldId="257"/>
            <ac:spMk id="37" creationId="{F8B4A4AC-A6E1-AC32-D171-D9B972CEB155}"/>
          </ac:spMkLst>
        </pc:spChg>
        <pc:spChg chg="mod">
          <ac:chgData name="雄介 國本" userId="37588d4f08e98cf0" providerId="LiveId" clId="{FF2A9FED-7758-BA49-834A-9397D43FCF5B}" dt="2024-01-24T00:35:08" v="340" actId="1076"/>
          <ac:spMkLst>
            <pc:docMk/>
            <pc:sldMk cId="1710634627" sldId="257"/>
            <ac:spMk id="38" creationId="{3CB2A57F-5FC6-A184-E84D-3D28CC3C214B}"/>
          </ac:spMkLst>
        </pc:spChg>
        <pc:graphicFrameChg chg="mod">
          <ac:chgData name="雄介 國本" userId="37588d4f08e98cf0" providerId="LiveId" clId="{FF2A9FED-7758-BA49-834A-9397D43FCF5B}" dt="2024-01-24T00:38:59.686" v="379"/>
          <ac:graphicFrameMkLst>
            <pc:docMk/>
            <pc:sldMk cId="1710634627" sldId="257"/>
            <ac:graphicFrameMk id="4" creationId="{D8362EF2-EEE9-F96B-8E46-7BCF51F11861}"/>
          </ac:graphicFrameMkLst>
        </pc:graphicFrameChg>
      </pc:sldChg>
    </pc:docChg>
  </pc:docChgLst>
  <pc:docChgLst>
    <pc:chgData name="Yusuke Kunimoto" userId="37588d4f08e98cf0" providerId="LiveId" clId="{928ADCE8-CD41-EC47-A77D-F31D862716BE}"/>
    <pc:docChg chg="custSel addSld modSld sldOrd">
      <pc:chgData name="Yusuke Kunimoto" userId="37588d4f08e98cf0" providerId="LiveId" clId="{928ADCE8-CD41-EC47-A77D-F31D862716BE}" dt="2024-03-06T12:13:44.261" v="256" actId="207"/>
      <pc:docMkLst>
        <pc:docMk/>
      </pc:docMkLst>
      <pc:sldChg chg="addSp delSp modSp mod">
        <pc:chgData name="Yusuke Kunimoto" userId="37588d4f08e98cf0" providerId="LiveId" clId="{928ADCE8-CD41-EC47-A77D-F31D862716BE}" dt="2024-03-06T12:13:44.261" v="256" actId="207"/>
        <pc:sldMkLst>
          <pc:docMk/>
          <pc:sldMk cId="558466156" sldId="258"/>
        </pc:sldMkLst>
        <pc:spChg chg="mod">
          <ac:chgData name="Yusuke Kunimoto" userId="37588d4f08e98cf0" providerId="LiveId" clId="{928ADCE8-CD41-EC47-A77D-F31D862716BE}" dt="2024-03-05T11:29:55.147" v="50" actId="207"/>
          <ac:spMkLst>
            <pc:docMk/>
            <pc:sldMk cId="558466156" sldId="258"/>
            <ac:spMk id="4" creationId="{DC7325EB-93C6-AB5D-A6D5-3CFC091DE79C}"/>
          </ac:spMkLst>
        </pc:spChg>
        <pc:spChg chg="mod">
          <ac:chgData name="Yusuke Kunimoto" userId="37588d4f08e98cf0" providerId="LiveId" clId="{928ADCE8-CD41-EC47-A77D-F31D862716BE}" dt="2024-03-05T11:30:15.489" v="57" actId="207"/>
          <ac:spMkLst>
            <pc:docMk/>
            <pc:sldMk cId="558466156" sldId="258"/>
            <ac:spMk id="5" creationId="{65DF0F4D-FD75-5E82-3EBD-91E137AA0AA1}"/>
          </ac:spMkLst>
        </pc:spChg>
        <pc:spChg chg="mod">
          <ac:chgData name="Yusuke Kunimoto" userId="37588d4f08e98cf0" providerId="LiveId" clId="{928ADCE8-CD41-EC47-A77D-F31D862716BE}" dt="2024-03-05T11:29:00.765" v="33" actId="1076"/>
          <ac:spMkLst>
            <pc:docMk/>
            <pc:sldMk cId="558466156" sldId="258"/>
            <ac:spMk id="6" creationId="{406A7FA7-3B6A-55B2-6A1C-9121E203434C}"/>
          </ac:spMkLst>
        </pc:spChg>
        <pc:spChg chg="del">
          <ac:chgData name="Yusuke Kunimoto" userId="37588d4f08e98cf0" providerId="LiveId" clId="{928ADCE8-CD41-EC47-A77D-F31D862716BE}" dt="2024-03-05T11:27:19.690" v="0" actId="478"/>
          <ac:spMkLst>
            <pc:docMk/>
            <pc:sldMk cId="558466156" sldId="258"/>
            <ac:spMk id="10" creationId="{242B65AC-3A50-5B7B-6A1C-66E7F0E0817A}"/>
          </ac:spMkLst>
        </pc:spChg>
        <pc:spChg chg="mod">
          <ac:chgData name="Yusuke Kunimoto" userId="37588d4f08e98cf0" providerId="LiveId" clId="{928ADCE8-CD41-EC47-A77D-F31D862716BE}" dt="2024-03-06T12:13:44.261" v="256" actId="207"/>
          <ac:spMkLst>
            <pc:docMk/>
            <pc:sldMk cId="558466156" sldId="258"/>
            <ac:spMk id="12" creationId="{DB5E8374-9612-00AB-B086-3B1B711B2D64}"/>
          </ac:spMkLst>
        </pc:spChg>
        <pc:picChg chg="add del">
          <ac:chgData name="Yusuke Kunimoto" userId="37588d4f08e98cf0" providerId="LiveId" clId="{928ADCE8-CD41-EC47-A77D-F31D862716BE}" dt="2024-03-05T11:40:42.027" v="60" actId="21"/>
          <ac:picMkLst>
            <pc:docMk/>
            <pc:sldMk cId="558466156" sldId="258"/>
            <ac:picMk id="13" creationId="{96839E93-DFB2-B780-1979-9A8B92F4FB32}"/>
          </ac:picMkLst>
        </pc:picChg>
        <pc:cxnChg chg="mod">
          <ac:chgData name="Yusuke Kunimoto" userId="37588d4f08e98cf0" providerId="LiveId" clId="{928ADCE8-CD41-EC47-A77D-F31D862716BE}" dt="2024-03-05T11:29:00.765" v="33" actId="1076"/>
          <ac:cxnSpMkLst>
            <pc:docMk/>
            <pc:sldMk cId="558466156" sldId="258"/>
            <ac:cxnSpMk id="7" creationId="{5722A906-4AE0-0EFE-2320-D7BA8128C16C}"/>
          </ac:cxnSpMkLst>
        </pc:cxnChg>
      </pc:sldChg>
      <pc:sldChg chg="addSp delSp modSp new mod ord">
        <pc:chgData name="Yusuke Kunimoto" userId="37588d4f08e98cf0" providerId="LiveId" clId="{928ADCE8-CD41-EC47-A77D-F31D862716BE}" dt="2024-03-06T12:13:38.330" v="255" actId="207"/>
        <pc:sldMkLst>
          <pc:docMk/>
          <pc:sldMk cId="2240887657" sldId="259"/>
        </pc:sldMkLst>
        <pc:spChg chg="del">
          <ac:chgData name="Yusuke Kunimoto" userId="37588d4f08e98cf0" providerId="LiveId" clId="{928ADCE8-CD41-EC47-A77D-F31D862716BE}" dt="2024-03-05T11:40:47.337" v="62" actId="478"/>
          <ac:spMkLst>
            <pc:docMk/>
            <pc:sldMk cId="2240887657" sldId="259"/>
            <ac:spMk id="2" creationId="{B7A59513-CCCF-FE31-56A7-6539D9A8AD17}"/>
          </ac:spMkLst>
        </pc:spChg>
        <pc:spChg chg="del">
          <ac:chgData name="Yusuke Kunimoto" userId="37588d4f08e98cf0" providerId="LiveId" clId="{928ADCE8-CD41-EC47-A77D-F31D862716BE}" dt="2024-03-05T11:40:45.635" v="61" actId="478"/>
          <ac:spMkLst>
            <pc:docMk/>
            <pc:sldMk cId="2240887657" sldId="259"/>
            <ac:spMk id="3" creationId="{0F83001F-6661-00EC-AF86-00DA4C8D993C}"/>
          </ac:spMkLst>
        </pc:spChg>
        <pc:spChg chg="add mod">
          <ac:chgData name="Yusuke Kunimoto" userId="37588d4f08e98cf0" providerId="LiveId" clId="{928ADCE8-CD41-EC47-A77D-F31D862716BE}" dt="2024-03-05T11:52:35.428" v="96" actId="404"/>
          <ac:spMkLst>
            <pc:docMk/>
            <pc:sldMk cId="2240887657" sldId="259"/>
            <ac:spMk id="6" creationId="{9C508B2C-F034-B8C1-FD21-2216EACF82C0}"/>
          </ac:spMkLst>
        </pc:spChg>
        <pc:spChg chg="add mod">
          <ac:chgData name="Yusuke Kunimoto" userId="37588d4f08e98cf0" providerId="LiveId" clId="{928ADCE8-CD41-EC47-A77D-F31D862716BE}" dt="2024-03-05T11:53:28.280" v="125" actId="1076"/>
          <ac:spMkLst>
            <pc:docMk/>
            <pc:sldMk cId="2240887657" sldId="259"/>
            <ac:spMk id="7" creationId="{638A66E9-3BDD-37CF-904A-70F1E2C11DDC}"/>
          </ac:spMkLst>
        </pc:spChg>
        <pc:spChg chg="add mod">
          <ac:chgData name="Yusuke Kunimoto" userId="37588d4f08e98cf0" providerId="LiveId" clId="{928ADCE8-CD41-EC47-A77D-F31D862716BE}" dt="2024-03-06T12:13:38.330" v="255" actId="207"/>
          <ac:spMkLst>
            <pc:docMk/>
            <pc:sldMk cId="2240887657" sldId="259"/>
            <ac:spMk id="8" creationId="{EC7FEDBE-A8A9-8DF8-AC44-35297CCCDD6A}"/>
          </ac:spMkLst>
        </pc:spChg>
        <pc:spChg chg="add mod">
          <ac:chgData name="Yusuke Kunimoto" userId="37588d4f08e98cf0" providerId="LiveId" clId="{928ADCE8-CD41-EC47-A77D-F31D862716BE}" dt="2024-03-05T12:12:16.469" v="249" actId="1076"/>
          <ac:spMkLst>
            <pc:docMk/>
            <pc:sldMk cId="2240887657" sldId="259"/>
            <ac:spMk id="9" creationId="{B9895C81-F577-5B48-1D6C-2546D3E62E82}"/>
          </ac:spMkLst>
        </pc:spChg>
        <pc:picChg chg="add del mod modCrop">
          <ac:chgData name="Yusuke Kunimoto" userId="37588d4f08e98cf0" providerId="LiveId" clId="{928ADCE8-CD41-EC47-A77D-F31D862716BE}" dt="2024-03-05T11:48:05.670" v="69" actId="478"/>
          <ac:picMkLst>
            <pc:docMk/>
            <pc:sldMk cId="2240887657" sldId="259"/>
            <ac:picMk id="4" creationId="{96839E93-DFB2-B780-1979-9A8B92F4FB32}"/>
          </ac:picMkLst>
        </pc:picChg>
        <pc:picChg chg="add mod modCrop">
          <ac:chgData name="Yusuke Kunimoto" userId="37588d4f08e98cf0" providerId="LiveId" clId="{928ADCE8-CD41-EC47-A77D-F31D862716BE}" dt="2024-03-05T11:51:01.333" v="75" actId="732"/>
          <ac:picMkLst>
            <pc:docMk/>
            <pc:sldMk cId="2240887657" sldId="259"/>
            <ac:picMk id="5" creationId="{5E755F38-8E80-43EA-E792-CAA68C94CFA7}"/>
          </ac:picMkLst>
        </pc:picChg>
      </pc:sldChg>
    </pc:docChg>
  </pc:docChgLst>
  <pc:docChgLst>
    <pc:chgData name="Yusuke Kunimoto" userId="37588d4f08e98cf0" providerId="LiveId" clId="{07779A8A-668F-3942-A2A5-93A3F987EB19}"/>
    <pc:docChg chg="undo custSel modSld">
      <pc:chgData name="Yusuke Kunimoto" userId="37588d4f08e98cf0" providerId="LiveId" clId="{07779A8A-668F-3942-A2A5-93A3F987EB19}" dt="2024-02-18T01:25:27.376" v="41" actId="20577"/>
      <pc:docMkLst>
        <pc:docMk/>
      </pc:docMkLst>
      <pc:sldChg chg="modSp mod">
        <pc:chgData name="Yusuke Kunimoto" userId="37588d4f08e98cf0" providerId="LiveId" clId="{07779A8A-668F-3942-A2A5-93A3F987EB19}" dt="2024-02-18T01:25:27.376" v="41" actId="20577"/>
        <pc:sldMkLst>
          <pc:docMk/>
          <pc:sldMk cId="558466156" sldId="258"/>
        </pc:sldMkLst>
        <pc:spChg chg="mod">
          <ac:chgData name="Yusuke Kunimoto" userId="37588d4f08e98cf0" providerId="LiveId" clId="{07779A8A-668F-3942-A2A5-93A3F987EB19}" dt="2024-02-18T01:25:20.001" v="39" actId="207"/>
          <ac:spMkLst>
            <pc:docMk/>
            <pc:sldMk cId="558466156" sldId="258"/>
            <ac:spMk id="4" creationId="{DC7325EB-93C6-AB5D-A6D5-3CFC091DE79C}"/>
          </ac:spMkLst>
        </pc:spChg>
        <pc:spChg chg="mod">
          <ac:chgData name="Yusuke Kunimoto" userId="37588d4f08e98cf0" providerId="LiveId" clId="{07779A8A-668F-3942-A2A5-93A3F987EB19}" dt="2024-02-18T01:25:16.999" v="38" actId="207"/>
          <ac:spMkLst>
            <pc:docMk/>
            <pc:sldMk cId="558466156" sldId="258"/>
            <ac:spMk id="5" creationId="{65DF0F4D-FD75-5E82-3EBD-91E137AA0AA1}"/>
          </ac:spMkLst>
        </pc:spChg>
        <pc:spChg chg="mod">
          <ac:chgData name="Yusuke Kunimoto" userId="37588d4f08e98cf0" providerId="LiveId" clId="{07779A8A-668F-3942-A2A5-93A3F987EB19}" dt="2024-02-18T01:25:27.376" v="41" actId="20577"/>
          <ac:spMkLst>
            <pc:docMk/>
            <pc:sldMk cId="558466156" sldId="258"/>
            <ac:spMk id="6" creationId="{406A7FA7-3B6A-55B2-6A1C-9121E203434C}"/>
          </ac:spMkLst>
        </pc:spChg>
        <pc:spChg chg="mod">
          <ac:chgData name="Yusuke Kunimoto" userId="37588d4f08e98cf0" providerId="LiveId" clId="{07779A8A-668F-3942-A2A5-93A3F987EB19}" dt="2024-02-18T01:25:11.849" v="37" actId="207"/>
          <ac:spMkLst>
            <pc:docMk/>
            <pc:sldMk cId="558466156" sldId="258"/>
            <ac:spMk id="10" creationId="{242B65AC-3A50-5B7B-6A1C-66E7F0E0817A}"/>
          </ac:spMkLst>
        </pc:spChg>
        <pc:spChg chg="mod">
          <ac:chgData name="Yusuke Kunimoto" userId="37588d4f08e98cf0" providerId="LiveId" clId="{07779A8A-668F-3942-A2A5-93A3F987EB19}" dt="2024-02-18T01:22:49.763" v="6" actId="207"/>
          <ac:spMkLst>
            <pc:docMk/>
            <pc:sldMk cId="558466156" sldId="258"/>
            <ac:spMk id="12" creationId="{DB5E8374-9612-00AB-B086-3B1B711B2D64}"/>
          </ac:spMkLst>
        </pc:spChg>
        <pc:cxnChg chg="mod">
          <ac:chgData name="Yusuke Kunimoto" userId="37588d4f08e98cf0" providerId="LiveId" clId="{07779A8A-668F-3942-A2A5-93A3F987EB19}" dt="2024-02-18T01:24:34.082" v="36" actId="1037"/>
          <ac:cxnSpMkLst>
            <pc:docMk/>
            <pc:sldMk cId="558466156" sldId="258"/>
            <ac:cxnSpMk id="7" creationId="{5722A906-4AE0-0EFE-2320-D7BA8128C16C}"/>
          </ac:cxnSpMkLst>
        </pc:cxnChg>
      </pc:sldChg>
    </pc:docChg>
  </pc:docChgLst>
  <pc:docChgLst>
    <pc:chgData name="雄介 國本" userId="37588d4f08e98cf0" providerId="LiveId" clId="{C62F719E-4246-D54C-9F5A-8D9C8B8C05C0}"/>
    <pc:docChg chg="undo custSel modSld">
      <pc:chgData name="雄介 國本" userId="37588d4f08e98cf0" providerId="LiveId" clId="{C62F719E-4246-D54C-9F5A-8D9C8B8C05C0}" dt="2023-12-07T12:25:12.395" v="92" actId="1076"/>
      <pc:docMkLst>
        <pc:docMk/>
      </pc:docMkLst>
      <pc:sldChg chg="addSp delSp modSp mod">
        <pc:chgData name="雄介 國本" userId="37588d4f08e98cf0" providerId="LiveId" clId="{C62F719E-4246-D54C-9F5A-8D9C8B8C05C0}" dt="2023-12-07T12:25:12.395" v="92" actId="1076"/>
        <pc:sldMkLst>
          <pc:docMk/>
          <pc:sldMk cId="3995223067" sldId="256"/>
        </pc:sldMkLst>
        <pc:spChg chg="mod">
          <ac:chgData name="雄介 國本" userId="37588d4f08e98cf0" providerId="LiveId" clId="{C62F719E-4246-D54C-9F5A-8D9C8B8C05C0}" dt="2023-12-07T12:19:14.218" v="55" actId="1076"/>
          <ac:spMkLst>
            <pc:docMk/>
            <pc:sldMk cId="3995223067" sldId="256"/>
            <ac:spMk id="2" creationId="{00000000-0000-0000-0000-000000000000}"/>
          </ac:spMkLst>
        </pc:spChg>
        <pc:spChg chg="mod">
          <ac:chgData name="雄介 國本" userId="37588d4f08e98cf0" providerId="LiveId" clId="{C62F719E-4246-D54C-9F5A-8D9C8B8C05C0}" dt="2023-12-07T12:15:19.054" v="30" actId="1037"/>
          <ac:spMkLst>
            <pc:docMk/>
            <pc:sldMk cId="3995223067" sldId="256"/>
            <ac:spMk id="3" creationId="{00000000-0000-0000-0000-000000000000}"/>
          </ac:spMkLst>
        </pc:spChg>
        <pc:spChg chg="mod">
          <ac:chgData name="雄介 國本" userId="37588d4f08e98cf0" providerId="LiveId" clId="{C62F719E-4246-D54C-9F5A-8D9C8B8C05C0}" dt="2023-12-07T12:25:12.395" v="92" actId="1076"/>
          <ac:spMkLst>
            <pc:docMk/>
            <pc:sldMk cId="3995223067" sldId="256"/>
            <ac:spMk id="5" creationId="{F85C195C-9099-F836-E846-2453506E9D0A}"/>
          </ac:spMkLst>
        </pc:spChg>
        <pc:spChg chg="add mod">
          <ac:chgData name="雄介 國本" userId="37588d4f08e98cf0" providerId="LiveId" clId="{C62F719E-4246-D54C-9F5A-8D9C8B8C05C0}" dt="2023-12-07T12:21:18.143" v="67" actId="1037"/>
          <ac:spMkLst>
            <pc:docMk/>
            <pc:sldMk cId="3995223067" sldId="256"/>
            <ac:spMk id="8" creationId="{51387C98-E8B6-BD17-F2EB-B86EF344DAB5}"/>
          </ac:spMkLst>
        </pc:spChg>
        <pc:spChg chg="add mod">
          <ac:chgData name="雄介 國本" userId="37588d4f08e98cf0" providerId="LiveId" clId="{C62F719E-4246-D54C-9F5A-8D9C8B8C05C0}" dt="2023-12-07T12:21:00.513" v="65" actId="1037"/>
          <ac:spMkLst>
            <pc:docMk/>
            <pc:sldMk cId="3995223067" sldId="256"/>
            <ac:spMk id="10" creationId="{5585EBF8-E0C6-2655-D584-8CF4C49D36B3}"/>
          </ac:spMkLst>
        </pc:spChg>
        <pc:spChg chg="del mod">
          <ac:chgData name="雄介 國本" userId="37588d4f08e98cf0" providerId="LiveId" clId="{C62F719E-4246-D54C-9F5A-8D9C8B8C05C0}" dt="2023-12-07T12:15:41.769" v="33" actId="478"/>
          <ac:spMkLst>
            <pc:docMk/>
            <pc:sldMk cId="3995223067" sldId="256"/>
            <ac:spMk id="11" creationId="{00000000-0000-0000-0000-000000000000}"/>
          </ac:spMkLst>
        </pc:spChg>
        <pc:spChg chg="del mod">
          <ac:chgData name="雄介 國本" userId="37588d4f08e98cf0" providerId="LiveId" clId="{C62F719E-4246-D54C-9F5A-8D9C8B8C05C0}" dt="2023-12-07T12:15:51.559" v="35" actId="478"/>
          <ac:spMkLst>
            <pc:docMk/>
            <pc:sldMk cId="3995223067" sldId="256"/>
            <ac:spMk id="12" creationId="{00000000-0000-0000-0000-000000000000}"/>
          </ac:spMkLst>
        </pc:spChg>
        <pc:spChg chg="del mod">
          <ac:chgData name="雄介 國本" userId="37588d4f08e98cf0" providerId="LiveId" clId="{C62F719E-4246-D54C-9F5A-8D9C8B8C05C0}" dt="2023-12-07T12:15:58.354" v="37" actId="478"/>
          <ac:spMkLst>
            <pc:docMk/>
            <pc:sldMk cId="3995223067" sldId="256"/>
            <ac:spMk id="13" creationId="{00000000-0000-0000-0000-000000000000}"/>
          </ac:spMkLst>
        </pc:spChg>
        <pc:spChg chg="del mod">
          <ac:chgData name="雄介 國本" userId="37588d4f08e98cf0" providerId="LiveId" clId="{C62F719E-4246-D54C-9F5A-8D9C8B8C05C0}" dt="2023-12-07T12:16:04.233" v="39" actId="478"/>
          <ac:spMkLst>
            <pc:docMk/>
            <pc:sldMk cId="3995223067" sldId="256"/>
            <ac:spMk id="14" creationId="{00000000-0000-0000-0000-000000000000}"/>
          </ac:spMkLst>
        </pc:spChg>
        <pc:spChg chg="del mod">
          <ac:chgData name="雄介 國本" userId="37588d4f08e98cf0" providerId="LiveId" clId="{C62F719E-4246-D54C-9F5A-8D9C8B8C05C0}" dt="2023-12-07T12:16:06.595" v="40" actId="478"/>
          <ac:spMkLst>
            <pc:docMk/>
            <pc:sldMk cId="3995223067" sldId="256"/>
            <ac:spMk id="15" creationId="{00000000-0000-0000-0000-000000000000}"/>
          </ac:spMkLst>
        </pc:spChg>
        <pc:spChg chg="mod">
          <ac:chgData name="雄介 國本" userId="37588d4f08e98cf0" providerId="LiveId" clId="{C62F719E-4246-D54C-9F5A-8D9C8B8C05C0}" dt="2023-12-07T12:21:29.720" v="68" actId="1037"/>
          <ac:spMkLst>
            <pc:docMk/>
            <pc:sldMk cId="3995223067" sldId="256"/>
            <ac:spMk id="16" creationId="{00000000-0000-0000-0000-000000000000}"/>
          </ac:spMkLst>
        </pc:spChg>
        <pc:spChg chg="mod">
          <ac:chgData name="雄介 國本" userId="37588d4f08e98cf0" providerId="LiveId" clId="{C62F719E-4246-D54C-9F5A-8D9C8B8C05C0}" dt="2023-12-07T12:21:11.440" v="66" actId="1037"/>
          <ac:spMkLst>
            <pc:docMk/>
            <pc:sldMk cId="3995223067" sldId="256"/>
            <ac:spMk id="17" creationId="{00000000-0000-0000-0000-000000000000}"/>
          </ac:spMkLst>
        </pc:spChg>
        <pc:spChg chg="mod">
          <ac:chgData name="雄介 國本" userId="37588d4f08e98cf0" providerId="LiveId" clId="{C62F719E-4246-D54C-9F5A-8D9C8B8C05C0}" dt="2023-12-07T12:20:42.424" v="62" actId="1037"/>
          <ac:spMkLst>
            <pc:docMk/>
            <pc:sldMk cId="3995223067" sldId="256"/>
            <ac:spMk id="18" creationId="{00000000-0000-0000-0000-000000000000}"/>
          </ac:spMkLst>
        </pc:spChg>
        <pc:spChg chg="mod">
          <ac:chgData name="雄介 國本" userId="37588d4f08e98cf0" providerId="LiveId" clId="{C62F719E-4246-D54C-9F5A-8D9C8B8C05C0}" dt="2023-12-07T12:22:29.599" v="79" actId="1037"/>
          <ac:spMkLst>
            <pc:docMk/>
            <pc:sldMk cId="3995223067" sldId="256"/>
            <ac:spMk id="19" creationId="{00000000-0000-0000-0000-000000000000}"/>
          </ac:spMkLst>
        </pc:spChg>
        <pc:spChg chg="add mod">
          <ac:chgData name="雄介 國本" userId="37588d4f08e98cf0" providerId="LiveId" clId="{C62F719E-4246-D54C-9F5A-8D9C8B8C05C0}" dt="2023-12-07T12:20:55.335" v="64" actId="1037"/>
          <ac:spMkLst>
            <pc:docMk/>
            <pc:sldMk cId="3995223067" sldId="256"/>
            <ac:spMk id="20" creationId="{3754B42C-9907-AA6C-7AA0-5C48B888B8EA}"/>
          </ac:spMkLst>
        </pc:spChg>
        <pc:spChg chg="add mod">
          <ac:chgData name="雄介 國本" userId="37588d4f08e98cf0" providerId="LiveId" clId="{C62F719E-4246-D54C-9F5A-8D9C8B8C05C0}" dt="2023-12-07T12:21:49.557" v="71" actId="1037"/>
          <ac:spMkLst>
            <pc:docMk/>
            <pc:sldMk cId="3995223067" sldId="256"/>
            <ac:spMk id="21" creationId="{E24E748A-1E95-4B2C-4DB9-70AE8FF0A3C9}"/>
          </ac:spMkLst>
        </pc:spChg>
        <pc:spChg chg="add mod">
          <ac:chgData name="雄介 國本" userId="37588d4f08e98cf0" providerId="LiveId" clId="{C62F719E-4246-D54C-9F5A-8D9C8B8C05C0}" dt="2023-12-07T12:21:58.281" v="73" actId="1037"/>
          <ac:spMkLst>
            <pc:docMk/>
            <pc:sldMk cId="3995223067" sldId="256"/>
            <ac:spMk id="22" creationId="{677D8F34-2E48-6BD3-22E0-C54471387A32}"/>
          </ac:spMkLst>
        </pc:spChg>
        <pc:spChg chg="add mod">
          <ac:chgData name="雄介 國本" userId="37588d4f08e98cf0" providerId="LiveId" clId="{C62F719E-4246-D54C-9F5A-8D9C8B8C05C0}" dt="2023-12-07T12:22:05.538" v="75" actId="1037"/>
          <ac:spMkLst>
            <pc:docMk/>
            <pc:sldMk cId="3995223067" sldId="256"/>
            <ac:spMk id="23" creationId="{0AE39B81-3D23-A5FD-1B40-1CF6F6647E44}"/>
          </ac:spMkLst>
        </pc:spChg>
        <pc:spChg chg="add mod">
          <ac:chgData name="雄介 國本" userId="37588d4f08e98cf0" providerId="LiveId" clId="{C62F719E-4246-D54C-9F5A-8D9C8B8C05C0}" dt="2023-12-07T12:23:27.073" v="86" actId="1076"/>
          <ac:spMkLst>
            <pc:docMk/>
            <pc:sldMk cId="3995223067" sldId="256"/>
            <ac:spMk id="24" creationId="{0E37F554-9227-13D4-6FD4-332C7BFF1109}"/>
          </ac:spMkLst>
        </pc:spChg>
        <pc:spChg chg="add mod">
          <ac:chgData name="雄介 國本" userId="37588d4f08e98cf0" providerId="LiveId" clId="{C62F719E-4246-D54C-9F5A-8D9C8B8C05C0}" dt="2023-12-07T12:23:46.021" v="88" actId="1076"/>
          <ac:spMkLst>
            <pc:docMk/>
            <pc:sldMk cId="3995223067" sldId="256"/>
            <ac:spMk id="25" creationId="{DACF262F-4A98-6EC5-75FD-586D5F874D5B}"/>
          </ac:spMkLst>
        </pc:spChg>
        <pc:picChg chg="add mod modCrop">
          <ac:chgData name="雄介 國本" userId="37588d4f08e98cf0" providerId="LiveId" clId="{C62F719E-4246-D54C-9F5A-8D9C8B8C05C0}" dt="2023-12-07T12:24:54.016" v="90" actId="1076"/>
          <ac:picMkLst>
            <pc:docMk/>
            <pc:sldMk cId="3995223067" sldId="256"/>
            <ac:picMk id="4" creationId="{F6783AAF-2CC5-5701-E38C-2D95ABCFFA9F}"/>
          </ac:picMkLst>
        </pc:picChg>
        <pc:picChg chg="del">
          <ac:chgData name="雄介 國本" userId="37588d4f08e98cf0" providerId="LiveId" clId="{C62F719E-4246-D54C-9F5A-8D9C8B8C05C0}" dt="2023-12-07T12:06:52.056" v="0" actId="478"/>
          <ac:picMkLst>
            <pc:docMk/>
            <pc:sldMk cId="3995223067" sldId="256"/>
            <ac:picMk id="6" creationId="{00000000-0000-0000-0000-000000000000}"/>
          </ac:picMkLst>
        </pc:picChg>
        <pc:picChg chg="mod">
          <ac:chgData name="雄介 國本" userId="37588d4f08e98cf0" providerId="LiveId" clId="{C62F719E-4246-D54C-9F5A-8D9C8B8C05C0}" dt="2023-12-07T12:09:58.552" v="21" actId="1076"/>
          <ac:picMkLst>
            <pc:docMk/>
            <pc:sldMk cId="3995223067" sldId="256"/>
            <ac:picMk id="9" creationId="{D4B51062-ACB7-07DC-22DD-6BAAD791135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D7DA3B-B862-4C07-53AF-4C4C66ED68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D0A9729-4213-692B-4A9A-A5DEEB2F82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B3943E-19FA-E5DD-5D36-7C97F3492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7BDEF1-5DF3-24BE-268D-AAEC05621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74FE74-8ADE-90B6-6659-9EFCB82DF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05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0E0DEB-24B8-6C1E-5349-87C41F73AB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2288376-5433-C646-9E65-D64A38D78F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DD6835-4655-E7CD-2658-4FE5B6702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3E1E3D-E7D7-568E-EF98-C181677B3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33E205-DA95-F675-A861-3DE82944F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904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065551D-BD1E-D99D-7692-D498A78DC6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6517B2C-83E6-23FD-6FAE-FE77729D13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85627D-4ED0-9D8B-C19D-6EDA9B7CC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ADA505-16A9-C2EF-B06A-01522190D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790B4A-5765-39A1-45E5-E2DE82119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4348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FB57B6-A549-805E-2D39-917AB84AF0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ABF96E-76EB-3997-2582-3958B735D3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B32ADD-54A9-CF56-008D-A795A687A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5D0BC0-64C4-8C68-4C5C-73FC27970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0A16BD-03FD-A374-A743-5E4BE845A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269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19DA84-E01F-0896-6454-FB13EA874C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E85A2E3-0652-0607-25B9-68AAEFDCBE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FB983A-9BEB-3601-3E7B-38D997ACC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352DDC-6A23-9BAB-9E38-E989FF588B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D2F897-5510-A7CA-717D-FD30FB883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335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8D5376-806C-5AF6-0C9D-B5A91D42E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908BB8C-C55F-3007-E935-55500DA9C4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E582DCE-2808-9624-8414-CA39216398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D7D6CB0-E74F-2E28-A8B5-FA24C0ECD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400CBD-E567-D048-45C2-00D1DEAD43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71165E-481B-202F-D9F4-EA1F9F87B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9516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E24DF2-FDD5-5BC4-F589-F7DB74DD1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65FD305-4613-BA59-DC3C-78B3A1E94D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167C901-6757-21D4-AAC4-E94BB755AB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32F7176-8ED7-61FE-0DAA-27AE4D8DC9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A6CC461-DBB5-484C-8869-700E1C9873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05D1441-7A91-6BFB-0CCC-A730488C5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BEB0799-BD54-DA7E-EEFC-CB92D7474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95D4132-A884-D618-A2BF-01625186C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238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6C04F1-2AA4-0A59-4474-13BFD3AEA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76BED21-816F-2E3A-6D17-C050E81F0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7765F4F-CE24-7686-7076-8EAE40A8A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4971297-E080-C4B3-0967-7B96F488D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6877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4DE85C6-22F9-F658-EC97-26820E4A1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B5AEA67-8CA9-087E-A064-DD36E015A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B202C70-E33E-CCBC-3506-833BDCA32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044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AAE1AB-B4F6-604C-5E09-5AABB85771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CFB664B-E008-7660-D654-3B9F2C2E32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1D6605-FD7F-65FC-8FC4-F4A273C20B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FD0861D-065B-E0ED-2359-5D0ADCFFA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40A21B4-E7AF-C9D6-8C5C-08BE80FE3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5BEF9F2-4552-7A4D-D772-EFACC60A7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501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254218-1B6F-159D-EF39-C89D9A098A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BDE757E-4FFF-3201-8DF9-5343279653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E713667-A054-8402-D005-CF692D471E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839967-742C-712E-09DA-1E9674908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D698B4E-0D39-D4C0-317A-89F9A6CDA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6D20166-EC07-19A6-6AAA-3A29ED322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9913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47B18BA-1DEF-F30A-037B-DE0898EE59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FCD045-57F3-9866-ED2C-69D23BEA4B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A50B77-555E-9D12-7110-5310EA3ADC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AA546-7D2C-C941-9CA6-5854B0116F77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2D8BDF-77C7-857D-6F78-479EF3EF5B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2D204B-E3A3-3050-59AD-A64DE4FC27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D2E2D-C175-1346-9ECE-1EF83269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338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DC7325EB-93C6-AB5D-A6D5-3CFC091DE79C}"/>
              </a:ext>
            </a:extLst>
          </p:cNvPr>
          <p:cNvSpPr/>
          <p:nvPr/>
        </p:nvSpPr>
        <p:spPr>
          <a:xfrm>
            <a:off x="536782" y="1193368"/>
            <a:ext cx="7776000" cy="7079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sponded to the questionnaire and provided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tten informed consent (n=704)</a:t>
            </a:r>
            <a:endParaRPr kumimoji="1"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5DF0F4D-FD75-5E82-3EBD-91E137AA0AA1}"/>
              </a:ext>
            </a:extLst>
          </p:cNvPr>
          <p:cNvSpPr/>
          <p:nvPr/>
        </p:nvSpPr>
        <p:spPr>
          <a:xfrm>
            <a:off x="5456903" y="2610685"/>
            <a:ext cx="6327051" cy="16830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from the analysis</a:t>
            </a:r>
            <a:endParaRPr kumimoji="1" lang="en-US" altLang="ja-JP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absent responses for ART adherence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15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erroneous ART adherence response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 (n=4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sing medications other than INSTI-STRs (n=298</a:t>
            </a:r>
            <a:r>
              <a:rPr lang="ja-JP" alt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en-US" altLang="ja-JP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06A7FA7-3B6A-55B2-6A1C-9121E203434C}"/>
              </a:ext>
            </a:extLst>
          </p:cNvPr>
          <p:cNvSpPr/>
          <p:nvPr/>
        </p:nvSpPr>
        <p:spPr>
          <a:xfrm>
            <a:off x="536782" y="5003061"/>
            <a:ext cx="7776000" cy="7079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luded in the analysi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387)</a:t>
            </a:r>
            <a:endParaRPr kumimoji="1"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5722A906-4AE0-0EFE-2320-D7BA8128C16C}"/>
              </a:ext>
            </a:extLst>
          </p:cNvPr>
          <p:cNvCxnSpPr>
            <a:cxnSpLocks/>
            <a:stCxn id="4" idx="2"/>
            <a:endCxn id="6" idx="0"/>
          </p:cNvCxnSpPr>
          <p:nvPr/>
        </p:nvCxnSpPr>
        <p:spPr>
          <a:xfrm>
            <a:off x="4424782" y="1901330"/>
            <a:ext cx="0" cy="3101731"/>
          </a:xfrm>
          <a:prstGeom prst="straightConnector1">
            <a:avLst/>
          </a:prstGeom>
          <a:ln w="19050">
            <a:solidFill>
              <a:schemeClr val="tx1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E7ECB3ED-7415-E950-32FB-E7320D36774E}"/>
              </a:ext>
            </a:extLst>
          </p:cNvPr>
          <p:cNvCxnSpPr>
            <a:cxnSpLocks/>
          </p:cNvCxnSpPr>
          <p:nvPr/>
        </p:nvCxnSpPr>
        <p:spPr>
          <a:xfrm>
            <a:off x="4424782" y="3439932"/>
            <a:ext cx="1044000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B5E8374-9612-00AB-B086-3B1B711B2D64}"/>
              </a:ext>
            </a:extLst>
          </p:cNvPr>
          <p:cNvSpPr txBox="1"/>
          <p:nvPr/>
        </p:nvSpPr>
        <p:spPr>
          <a:xfrm>
            <a:off x="536781" y="6051046"/>
            <a:ext cx="59051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S1.</a:t>
            </a:r>
            <a:r>
              <a:rPr lang="en-US" altLang="ja-JP" sz="18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 Patient enrollment flowchart.</a:t>
            </a:r>
            <a:endParaRPr lang="ja-JP" altLang="ja-JP" sz="1800" kern="100" dirty="0">
              <a:effectLst/>
              <a:latin typeface="Helvetica" pitchFamily="2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8466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1</TotalTime>
  <Words>70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國本 雄介</dc:creator>
  <cp:lastModifiedBy>将秀 福土</cp:lastModifiedBy>
  <cp:revision>26</cp:revision>
  <dcterms:created xsi:type="dcterms:W3CDTF">2023-12-06T12:16:06Z</dcterms:created>
  <dcterms:modified xsi:type="dcterms:W3CDTF">2024-05-12T00:30:17Z</dcterms:modified>
</cp:coreProperties>
</file>